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9" r:id="rId2"/>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756A2E1D-D6C3-D84A-8B61-0A654652ABB6}" v="8" dt="2024-11-28T03:38:06.100"/>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6270" autoAdjust="0"/>
    <p:restoredTop sz="96327"/>
  </p:normalViewPr>
  <p:slideViewPr>
    <p:cSldViewPr snapToGrid="0">
      <p:cViewPr varScale="1">
        <p:scale>
          <a:sx n="124" d="100"/>
          <a:sy n="124" d="100"/>
        </p:scale>
        <p:origin x="1136"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microsoft.com/office/2015/10/relationships/revisionInfo" Target="revisionInfo.xml"/><Relationship Id="rId3" Type="http://schemas.openxmlformats.org/officeDocument/2006/relationships/presProps" Target="presProps.xml"/><Relationship Id="rId7"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小澤 正和" userId="02998379d0db661d" providerId="LiveId" clId="{756A2E1D-D6C3-D84A-8B61-0A654652ABB6}"/>
    <pc:docChg chg="custSel addSld delSld modSld">
      <pc:chgData name="小澤 正和" userId="02998379d0db661d" providerId="LiveId" clId="{756A2E1D-D6C3-D84A-8B61-0A654652ABB6}" dt="2024-11-28T03:39:02.401" v="160" actId="2696"/>
      <pc:docMkLst>
        <pc:docMk/>
      </pc:docMkLst>
      <pc:sldChg chg="del">
        <pc:chgData name="小澤 正和" userId="02998379d0db661d" providerId="LiveId" clId="{756A2E1D-D6C3-D84A-8B61-0A654652ABB6}" dt="2024-11-28T03:29:19.382" v="1" actId="2696"/>
        <pc:sldMkLst>
          <pc:docMk/>
          <pc:sldMk cId="2128380218" sldId="256"/>
        </pc:sldMkLst>
      </pc:sldChg>
      <pc:sldChg chg="addSp delSp modSp new mod">
        <pc:chgData name="小澤 正和" userId="02998379d0db661d" providerId="LiveId" clId="{756A2E1D-D6C3-D84A-8B61-0A654652ABB6}" dt="2024-11-28T03:33:04.294" v="23" actId="1076"/>
        <pc:sldMkLst>
          <pc:docMk/>
          <pc:sldMk cId="3740614164" sldId="257"/>
        </pc:sldMkLst>
        <pc:spChg chg="del">
          <ac:chgData name="小澤 正和" userId="02998379d0db661d" providerId="LiveId" clId="{756A2E1D-D6C3-D84A-8B61-0A654652ABB6}" dt="2024-11-28T03:29:40.982" v="3" actId="478"/>
          <ac:spMkLst>
            <pc:docMk/>
            <pc:sldMk cId="3740614164" sldId="257"/>
            <ac:spMk id="2" creationId="{7A4C6509-4466-5DA1-FED1-B567080F4448}"/>
          </ac:spMkLst>
        </pc:spChg>
        <pc:spChg chg="del">
          <ac:chgData name="小澤 正和" userId="02998379d0db661d" providerId="LiveId" clId="{756A2E1D-D6C3-D84A-8B61-0A654652ABB6}" dt="2024-11-28T03:29:38.176" v="2"/>
          <ac:spMkLst>
            <pc:docMk/>
            <pc:sldMk cId="3740614164" sldId="257"/>
            <ac:spMk id="3" creationId="{F0B52936-B30D-5A53-B965-38411A8DFE04}"/>
          </ac:spMkLst>
        </pc:spChg>
        <pc:spChg chg="add mod">
          <ac:chgData name="小澤 正和" userId="02998379d0db661d" providerId="LiveId" clId="{756A2E1D-D6C3-D84A-8B61-0A654652ABB6}" dt="2024-11-28T03:33:04.294" v="23" actId="1076"/>
          <ac:spMkLst>
            <pc:docMk/>
            <pc:sldMk cId="3740614164" sldId="257"/>
            <ac:spMk id="6" creationId="{FA8201C6-A104-FEE2-B030-B931D9EB6EAE}"/>
          </ac:spMkLst>
        </pc:spChg>
        <pc:picChg chg="add mod">
          <ac:chgData name="小澤 正和" userId="02998379d0db661d" providerId="LiveId" clId="{756A2E1D-D6C3-D84A-8B61-0A654652ABB6}" dt="2024-11-28T03:30:35.025" v="11" actId="14100"/>
          <ac:picMkLst>
            <pc:docMk/>
            <pc:sldMk cId="3740614164" sldId="257"/>
            <ac:picMk id="5" creationId="{659FA2B7-2E22-2544-6CB3-82B03F027178}"/>
          </ac:picMkLst>
        </pc:picChg>
      </pc:sldChg>
      <pc:sldChg chg="addSp delSp modSp add mod">
        <pc:chgData name="小澤 正和" userId="02998379d0db661d" providerId="LiveId" clId="{756A2E1D-D6C3-D84A-8B61-0A654652ABB6}" dt="2024-11-28T03:35:23.639" v="59" actId="1037"/>
        <pc:sldMkLst>
          <pc:docMk/>
          <pc:sldMk cId="2168892186" sldId="258"/>
        </pc:sldMkLst>
        <pc:spChg chg="del mod">
          <ac:chgData name="小澤 正和" userId="02998379d0db661d" providerId="LiveId" clId="{756A2E1D-D6C3-D84A-8B61-0A654652ABB6}" dt="2024-11-28T03:34:48.510" v="39" actId="478"/>
          <ac:spMkLst>
            <pc:docMk/>
            <pc:sldMk cId="2168892186" sldId="258"/>
            <ac:spMk id="6" creationId="{6D445B83-46D4-9D5E-87D7-ED43FC12DD3A}"/>
          </ac:spMkLst>
        </pc:spChg>
        <pc:spChg chg="add del mod">
          <ac:chgData name="小澤 正和" userId="02998379d0db661d" providerId="LiveId" clId="{756A2E1D-D6C3-D84A-8B61-0A654652ABB6}" dt="2024-11-28T03:34:08.765" v="32" actId="478"/>
          <ac:spMkLst>
            <pc:docMk/>
            <pc:sldMk cId="2168892186" sldId="258"/>
            <ac:spMk id="7" creationId="{0F5F9685-D5A0-932C-40AD-12FA63848C98}"/>
          </ac:spMkLst>
        </pc:spChg>
        <pc:spChg chg="add mod">
          <ac:chgData name="小澤 正和" userId="02998379d0db661d" providerId="LiveId" clId="{756A2E1D-D6C3-D84A-8B61-0A654652ABB6}" dt="2024-11-28T03:35:23.639" v="59" actId="1037"/>
          <ac:spMkLst>
            <pc:docMk/>
            <pc:sldMk cId="2168892186" sldId="258"/>
            <ac:spMk id="8" creationId="{8C7B7E6C-AAFB-781C-3B1A-D474E5EC56DC}"/>
          </ac:spMkLst>
        </pc:spChg>
        <pc:picChg chg="add mod">
          <ac:chgData name="小澤 正和" userId="02998379d0db661d" providerId="LiveId" clId="{756A2E1D-D6C3-D84A-8B61-0A654652ABB6}" dt="2024-11-28T03:33:44.727" v="30" actId="1076"/>
          <ac:picMkLst>
            <pc:docMk/>
            <pc:sldMk cId="2168892186" sldId="258"/>
            <ac:picMk id="3" creationId="{C084297A-B578-A5E3-1D1E-48253973EB44}"/>
          </ac:picMkLst>
        </pc:picChg>
        <pc:picChg chg="del">
          <ac:chgData name="小澤 正和" userId="02998379d0db661d" providerId="LiveId" clId="{756A2E1D-D6C3-D84A-8B61-0A654652ABB6}" dt="2024-11-28T03:33:40.398" v="29" actId="478"/>
          <ac:picMkLst>
            <pc:docMk/>
            <pc:sldMk cId="2168892186" sldId="258"/>
            <ac:picMk id="5" creationId="{73AA2F3E-FE34-C79F-E060-FAB33B7AEC72}"/>
          </ac:picMkLst>
        </pc:picChg>
      </pc:sldChg>
      <pc:sldChg chg="addSp delSp modSp add mod">
        <pc:chgData name="小澤 正和" userId="02998379d0db661d" providerId="LiveId" clId="{756A2E1D-D6C3-D84A-8B61-0A654652ABB6}" dt="2024-11-28T03:36:12.135" v="68"/>
        <pc:sldMkLst>
          <pc:docMk/>
          <pc:sldMk cId="4082849156" sldId="259"/>
        </pc:sldMkLst>
        <pc:spChg chg="mod">
          <ac:chgData name="小澤 正和" userId="02998379d0db661d" providerId="LiveId" clId="{756A2E1D-D6C3-D84A-8B61-0A654652ABB6}" dt="2024-11-28T03:36:12.135" v="68"/>
          <ac:spMkLst>
            <pc:docMk/>
            <pc:sldMk cId="4082849156" sldId="259"/>
            <ac:spMk id="8" creationId="{9D2273A4-EC94-B309-8DC2-EF6541002E04}"/>
          </ac:spMkLst>
        </pc:spChg>
        <pc:picChg chg="del">
          <ac:chgData name="小澤 正和" userId="02998379d0db661d" providerId="LiveId" clId="{756A2E1D-D6C3-D84A-8B61-0A654652ABB6}" dt="2024-11-28T03:35:47.820" v="65" actId="478"/>
          <ac:picMkLst>
            <pc:docMk/>
            <pc:sldMk cId="4082849156" sldId="259"/>
            <ac:picMk id="3" creationId="{7477AF9B-AF22-45DB-D618-8377EC5EDE00}"/>
          </ac:picMkLst>
        </pc:picChg>
        <pc:picChg chg="add mod">
          <ac:chgData name="小澤 正和" userId="02998379d0db661d" providerId="LiveId" clId="{756A2E1D-D6C3-D84A-8B61-0A654652ABB6}" dt="2024-11-28T03:35:52.108" v="66" actId="1076"/>
          <ac:picMkLst>
            <pc:docMk/>
            <pc:sldMk cId="4082849156" sldId="259"/>
            <ac:picMk id="4" creationId="{67EB3DEA-24AB-9936-1311-385367AADEFB}"/>
          </ac:picMkLst>
        </pc:picChg>
      </pc:sldChg>
      <pc:sldChg chg="addSp delSp modSp add mod">
        <pc:chgData name="小澤 正和" userId="02998379d0db661d" providerId="LiveId" clId="{756A2E1D-D6C3-D84A-8B61-0A654652ABB6}" dt="2024-11-28T03:36:51.340" v="103"/>
        <pc:sldMkLst>
          <pc:docMk/>
          <pc:sldMk cId="2975597098" sldId="260"/>
        </pc:sldMkLst>
        <pc:spChg chg="mod">
          <ac:chgData name="小澤 正和" userId="02998379d0db661d" providerId="LiveId" clId="{756A2E1D-D6C3-D84A-8B61-0A654652ABB6}" dt="2024-11-28T03:36:51.340" v="103"/>
          <ac:spMkLst>
            <pc:docMk/>
            <pc:sldMk cId="2975597098" sldId="260"/>
            <ac:spMk id="8" creationId="{6829FD86-27DC-7036-8075-96227C431EA0}"/>
          </ac:spMkLst>
        </pc:spChg>
        <pc:picChg chg="add mod">
          <ac:chgData name="小澤 正和" userId="02998379d0db661d" providerId="LiveId" clId="{756A2E1D-D6C3-D84A-8B61-0A654652ABB6}" dt="2024-11-28T03:36:38.605" v="101" actId="1037"/>
          <ac:picMkLst>
            <pc:docMk/>
            <pc:sldMk cId="2975597098" sldId="260"/>
            <ac:picMk id="3" creationId="{8364A634-4F9C-EF35-C446-968A556D7AF2}"/>
          </ac:picMkLst>
        </pc:picChg>
        <pc:picChg chg="del">
          <ac:chgData name="小澤 正和" userId="02998379d0db661d" providerId="LiveId" clId="{756A2E1D-D6C3-D84A-8B61-0A654652ABB6}" dt="2024-11-28T03:36:34.696" v="74" actId="478"/>
          <ac:picMkLst>
            <pc:docMk/>
            <pc:sldMk cId="2975597098" sldId="260"/>
            <ac:picMk id="4" creationId="{010537FF-4336-F3EF-7C34-3D678D29E985}"/>
          </ac:picMkLst>
        </pc:picChg>
      </pc:sldChg>
      <pc:sldChg chg="addSp delSp modSp add mod">
        <pc:chgData name="小澤 正和" userId="02998379d0db661d" providerId="LiveId" clId="{756A2E1D-D6C3-D84A-8B61-0A654652ABB6}" dt="2024-11-28T03:38:26.585" v="158" actId="14100"/>
        <pc:sldMkLst>
          <pc:docMk/>
          <pc:sldMk cId="2065523478" sldId="261"/>
        </pc:sldMkLst>
        <pc:spChg chg="add mod">
          <ac:chgData name="小澤 正和" userId="02998379d0db661d" providerId="LiveId" clId="{756A2E1D-D6C3-D84A-8B61-0A654652ABB6}" dt="2024-11-28T03:38:26.585" v="158" actId="14100"/>
          <ac:spMkLst>
            <pc:docMk/>
            <pc:sldMk cId="2065523478" sldId="261"/>
            <ac:spMk id="5" creationId="{CC3925B2-74DC-1355-CAB3-2E7E3DD67E31}"/>
          </ac:spMkLst>
        </pc:spChg>
        <pc:spChg chg="del mod">
          <ac:chgData name="小澤 正和" userId="02998379d0db661d" providerId="LiveId" clId="{756A2E1D-D6C3-D84A-8B61-0A654652ABB6}" dt="2024-11-28T03:38:05.143" v="151" actId="478"/>
          <ac:spMkLst>
            <pc:docMk/>
            <pc:sldMk cId="2065523478" sldId="261"/>
            <ac:spMk id="8" creationId="{1BED305C-0C8F-C102-A536-4E365B118B1C}"/>
          </ac:spMkLst>
        </pc:spChg>
        <pc:picChg chg="del">
          <ac:chgData name="小澤 正和" userId="02998379d0db661d" providerId="LiveId" clId="{756A2E1D-D6C3-D84A-8B61-0A654652ABB6}" dt="2024-11-28T03:37:09.527" v="109" actId="478"/>
          <ac:picMkLst>
            <pc:docMk/>
            <pc:sldMk cId="2065523478" sldId="261"/>
            <ac:picMk id="3" creationId="{E598ECA6-D13D-24D0-8FB2-6B7B2DB7AF99}"/>
          </ac:picMkLst>
        </pc:picChg>
        <pc:picChg chg="add mod">
          <ac:chgData name="小澤 正和" userId="02998379d0db661d" providerId="LiveId" clId="{756A2E1D-D6C3-D84A-8B61-0A654652ABB6}" dt="2024-11-28T03:37:15.101" v="144" actId="1037"/>
          <ac:picMkLst>
            <pc:docMk/>
            <pc:sldMk cId="2065523478" sldId="261"/>
            <ac:picMk id="4" creationId="{41465379-E857-B13F-82A2-29B696EB52C1}"/>
          </ac:picMkLst>
        </pc:picChg>
      </pc:sldChg>
      <pc:sldChg chg="add del">
        <pc:chgData name="小澤 正和" userId="02998379d0db661d" providerId="LiveId" clId="{756A2E1D-D6C3-D84A-8B61-0A654652ABB6}" dt="2024-11-28T03:39:02.401" v="160" actId="2696"/>
        <pc:sldMkLst>
          <pc:docMk/>
          <pc:sldMk cId="158286888" sldId="262"/>
        </pc:sldMkLst>
      </pc:sldChg>
    </pc:docChg>
  </pc:docChgLst>
  <pc:docChgLst>
    <pc:chgData name="小澤 正和" userId="02998379d0db661d" providerId="LiveId" clId="{8F967401-70B2-2044-9C35-79EAB163B1DA}"/>
    <pc:docChg chg="delSld">
      <pc:chgData name="小澤 正和" userId="02998379d0db661d" providerId="LiveId" clId="{8F967401-70B2-2044-9C35-79EAB163B1DA}" dt="2024-11-28T03:43:15.451" v="3" actId="2696"/>
      <pc:docMkLst>
        <pc:docMk/>
      </pc:docMkLst>
      <pc:sldChg chg="del">
        <pc:chgData name="小澤 正和" userId="02998379d0db661d" providerId="LiveId" clId="{8F967401-70B2-2044-9C35-79EAB163B1DA}" dt="2024-11-28T03:43:12.359" v="0" actId="2696"/>
        <pc:sldMkLst>
          <pc:docMk/>
          <pc:sldMk cId="3740614164" sldId="257"/>
        </pc:sldMkLst>
      </pc:sldChg>
      <pc:sldChg chg="del">
        <pc:chgData name="小澤 正和" userId="02998379d0db661d" providerId="LiveId" clId="{8F967401-70B2-2044-9C35-79EAB163B1DA}" dt="2024-11-28T03:43:13.242" v="1" actId="2696"/>
        <pc:sldMkLst>
          <pc:docMk/>
          <pc:sldMk cId="2168892186" sldId="258"/>
        </pc:sldMkLst>
      </pc:sldChg>
      <pc:sldChg chg="del">
        <pc:chgData name="小澤 正和" userId="02998379d0db661d" providerId="LiveId" clId="{8F967401-70B2-2044-9C35-79EAB163B1DA}" dt="2024-11-28T03:43:14.824" v="2" actId="2696"/>
        <pc:sldMkLst>
          <pc:docMk/>
          <pc:sldMk cId="2975597098" sldId="260"/>
        </pc:sldMkLst>
      </pc:sldChg>
      <pc:sldChg chg="del">
        <pc:chgData name="小澤 正和" userId="02998379d0db661d" providerId="LiveId" clId="{8F967401-70B2-2044-9C35-79EAB163B1DA}" dt="2024-11-28T03:43:15.451" v="3" actId="2696"/>
        <pc:sldMkLst>
          <pc:docMk/>
          <pc:sldMk cId="2065523478" sldId="261"/>
        </pc:sldMkLst>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サブタイトル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p:cNvSpPr>
            <a:spLocks noGrp="1"/>
          </p:cNvSpPr>
          <p:nvPr>
            <p:ph type="dt" sz="half" idx="10"/>
          </p:nvPr>
        </p:nvSpPr>
        <p:spPr/>
        <p:txBody>
          <a:bodyPr/>
          <a:lstStyle/>
          <a:p>
            <a:fld id="{0E02A643-9BB0-4E02-80B2-2C0A5E5D738E}" type="datetimeFigureOut">
              <a:rPr kumimoji="1" lang="ja-JP" altLang="en-US" smtClean="0"/>
              <a:t>2024/11/2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384910677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0E02A643-9BB0-4E02-80B2-2C0A5E5D738E}" type="datetimeFigureOut">
              <a:rPr kumimoji="1" lang="ja-JP" altLang="en-US" smtClean="0"/>
              <a:t>2024/11/2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25757471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0E02A643-9BB0-4E02-80B2-2C0A5E5D738E}" type="datetimeFigureOut">
              <a:rPr kumimoji="1" lang="ja-JP" altLang="en-US" smtClean="0"/>
              <a:t>2024/11/2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295086672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0E02A643-9BB0-4E02-80B2-2C0A5E5D738E}" type="datetimeFigureOut">
              <a:rPr kumimoji="1" lang="ja-JP" altLang="en-US" smtClean="0"/>
              <a:t>2024/11/2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204051585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kumimoji="1" lang="ja-JP" altLang="en-US"/>
              <a:t>マスター テキストの書式設定</a:t>
            </a:r>
          </a:p>
        </p:txBody>
      </p:sp>
      <p:sp>
        <p:nvSpPr>
          <p:cNvPr id="4" name="日付プレースホルダー 3"/>
          <p:cNvSpPr>
            <a:spLocks noGrp="1"/>
          </p:cNvSpPr>
          <p:nvPr>
            <p:ph type="dt" sz="half" idx="10"/>
          </p:nvPr>
        </p:nvSpPr>
        <p:spPr/>
        <p:txBody>
          <a:bodyPr/>
          <a:lstStyle/>
          <a:p>
            <a:fld id="{0E02A643-9BB0-4E02-80B2-2C0A5E5D738E}" type="datetimeFigureOut">
              <a:rPr kumimoji="1" lang="ja-JP" altLang="en-US" smtClean="0"/>
              <a:t>2024/11/2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408390478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p:cNvSpPr>
            <a:spLocks noGrp="1"/>
          </p:cNvSpPr>
          <p:nvPr>
            <p:ph type="dt" sz="half" idx="10"/>
          </p:nvPr>
        </p:nvSpPr>
        <p:spPr/>
        <p:txBody>
          <a:bodyPr/>
          <a:lstStyle/>
          <a:p>
            <a:fld id="{0E02A643-9BB0-4E02-80B2-2C0A5E5D738E}" type="datetimeFigureOut">
              <a:rPr kumimoji="1" lang="ja-JP" altLang="en-US" smtClean="0"/>
              <a:t>2024/11/28</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13954029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p:cNvSpPr>
            <a:spLocks noGrp="1"/>
          </p:cNvSpPr>
          <p:nvPr>
            <p:ph type="dt" sz="half" idx="10"/>
          </p:nvPr>
        </p:nvSpPr>
        <p:spPr/>
        <p:txBody>
          <a:bodyPr/>
          <a:lstStyle/>
          <a:p>
            <a:fld id="{0E02A643-9BB0-4E02-80B2-2C0A5E5D738E}" type="datetimeFigureOut">
              <a:rPr kumimoji="1" lang="ja-JP" altLang="en-US" smtClean="0"/>
              <a:t>2024/11/28</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79788490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日付プレースホルダー 2"/>
          <p:cNvSpPr>
            <a:spLocks noGrp="1"/>
          </p:cNvSpPr>
          <p:nvPr>
            <p:ph type="dt" sz="half" idx="10"/>
          </p:nvPr>
        </p:nvSpPr>
        <p:spPr/>
        <p:txBody>
          <a:bodyPr/>
          <a:lstStyle/>
          <a:p>
            <a:fld id="{0E02A643-9BB0-4E02-80B2-2C0A5E5D738E}" type="datetimeFigureOut">
              <a:rPr kumimoji="1" lang="ja-JP" altLang="en-US" smtClean="0"/>
              <a:t>2024/11/28</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53958886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0E02A643-9BB0-4E02-80B2-2C0A5E5D738E}" type="datetimeFigureOut">
              <a:rPr kumimoji="1" lang="ja-JP" altLang="en-US" smtClean="0"/>
              <a:t>2024/11/28</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204286081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0E02A643-9BB0-4E02-80B2-2C0A5E5D738E}" type="datetimeFigureOut">
              <a:rPr kumimoji="1" lang="ja-JP" altLang="en-US" smtClean="0"/>
              <a:t>2024/11/28</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388845109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0E02A643-9BB0-4E02-80B2-2C0A5E5D738E}" type="datetimeFigureOut">
              <a:rPr kumimoji="1" lang="ja-JP" altLang="en-US" smtClean="0"/>
              <a:t>2024/11/28</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218938791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0E02A643-9BB0-4E02-80B2-2C0A5E5D738E}" type="datetimeFigureOut">
              <a:rPr kumimoji="1" lang="ja-JP" altLang="en-US" smtClean="0"/>
              <a:t>2024/11/28</a:t>
            </a:fld>
            <a:endParaRPr kumimoji="1" lang="ja-JP" altLang="en-US"/>
          </a:p>
        </p:txBody>
      </p:sp>
      <p:sp>
        <p:nvSpPr>
          <p:cNvPr id="5" name="フッター プレースホルダー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290728973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E1233F2-4192-892D-F948-EC494E8C3691}"/>
            </a:ext>
          </a:extLst>
        </p:cNvPr>
        <p:cNvGrpSpPr/>
        <p:nvPr/>
      </p:nvGrpSpPr>
      <p:grpSpPr>
        <a:xfrm>
          <a:off x="0" y="0"/>
          <a:ext cx="0" cy="0"/>
          <a:chOff x="0" y="0"/>
          <a:chExt cx="0" cy="0"/>
        </a:xfrm>
      </p:grpSpPr>
      <p:sp>
        <p:nvSpPr>
          <p:cNvPr id="8" name="テキスト ボックス 7">
            <a:extLst>
              <a:ext uri="{FF2B5EF4-FFF2-40B4-BE49-F238E27FC236}">
                <a16:creationId xmlns:a16="http://schemas.microsoft.com/office/drawing/2014/main" id="{9D2273A4-EC94-B309-8DC2-EF6541002E04}"/>
              </a:ext>
            </a:extLst>
          </p:cNvPr>
          <p:cNvSpPr txBox="1"/>
          <p:nvPr/>
        </p:nvSpPr>
        <p:spPr>
          <a:xfrm>
            <a:off x="8530936" y="374074"/>
            <a:ext cx="3629891" cy="3970318"/>
          </a:xfrm>
          <a:prstGeom prst="rect">
            <a:avLst/>
          </a:prstGeom>
          <a:noFill/>
        </p:spPr>
        <p:txBody>
          <a:bodyPr wrap="square" rtlCol="0">
            <a:spAutoFit/>
          </a:bodyPr>
          <a:lstStyle/>
          <a:p>
            <a:r>
              <a:rPr kumimoji="1" lang="en" altLang="ja-JP" dirty="0">
                <a:latin typeface="Times New Roman" panose="02020603050405020304" pitchFamily="18" charset="0"/>
                <a:cs typeface="Times New Roman" panose="02020603050405020304" pitchFamily="18" charset="0"/>
              </a:rPr>
              <a:t>Figure S1. Surface-based morphometry analysis revealed that the score of Noise Pareidolia Test was associated with cortical volume in right medial orbitofrontal cortex (green), right lateral orbitofrontal cortex (green), right superior temporal cortex (blue), right middle temporal cortex (orange), right temporal pole (light blue), and right lateral occipital cortex (pink). (p &lt; 0.01 corrected by Monte Carlo simulation).</a:t>
            </a:r>
          </a:p>
          <a:p>
            <a:endParaRPr kumimoji="1" lang="ja-JP" altLang="en-US">
              <a:latin typeface="Times New Roman" panose="02020603050405020304" pitchFamily="18" charset="0"/>
              <a:cs typeface="Times New Roman" panose="02020603050405020304" pitchFamily="18" charset="0"/>
            </a:endParaRPr>
          </a:p>
        </p:txBody>
      </p:sp>
      <p:pic>
        <p:nvPicPr>
          <p:cNvPr id="4" name="図 3" descr="食品, グリーン, 空気, 飛ぶ が含まれている画像&#10;&#10;自動的に生成された説明">
            <a:extLst>
              <a:ext uri="{FF2B5EF4-FFF2-40B4-BE49-F238E27FC236}">
                <a16:creationId xmlns:a16="http://schemas.microsoft.com/office/drawing/2014/main" id="{67EB3DEA-24AB-9936-1311-385367AADEF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8375373" cy="6903700"/>
          </a:xfrm>
          <a:prstGeom prst="rect">
            <a:avLst/>
          </a:prstGeom>
        </p:spPr>
      </p:pic>
    </p:spTree>
    <p:extLst>
      <p:ext uri="{BB962C8B-B14F-4D97-AF65-F5344CB8AC3E}">
        <p14:creationId xmlns:p14="http://schemas.microsoft.com/office/powerpoint/2010/main" val="4082849156"/>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ptos" panose="020B000402020202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9</TotalTime>
  <Words>73</Words>
  <Application>Microsoft Macintosh PowerPoint</Application>
  <PresentationFormat>ワイド画面</PresentationFormat>
  <Paragraphs>1</Paragraphs>
  <Slides>1</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1</vt:i4>
      </vt:variant>
    </vt:vector>
  </HeadingPairs>
  <TitlesOfParts>
    <vt:vector size="6" baseType="lpstr">
      <vt:lpstr>Aptos</vt:lpstr>
      <vt:lpstr>Aptos Display</vt:lpstr>
      <vt:lpstr>Arial</vt:lpstr>
      <vt:lpstr>Times New Roman</vt:lpstr>
      <vt:lpstr>Office テーマ</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
  <cp:lastModifiedBy>小澤 正和</cp:lastModifiedBy>
  <cp:revision>1</cp:revision>
  <dcterms:created xsi:type="dcterms:W3CDTF">2024-11-28T03:28:48Z</dcterms:created>
  <dcterms:modified xsi:type="dcterms:W3CDTF">2024-11-28T03:43:22Z</dcterms:modified>
</cp:coreProperties>
</file>